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836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17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85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641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455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829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61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955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992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381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947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5F6C7-D272-4B78-87CE-E6359B1D9C9D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6E71E-A3E6-43C9-B745-CCD5758B6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224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8590" y="689811"/>
            <a:ext cx="8337583" cy="4815372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236133" y="5757334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25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biquinolines against sensitive strain D6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3848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7:30Z</dcterms:created>
  <dcterms:modified xsi:type="dcterms:W3CDTF">2020-08-04T16:36:29Z</dcterms:modified>
</cp:coreProperties>
</file>